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9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D38B9-3757-9101-5A4A-8A3E84174B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181981-8279-45FD-DF38-E44EDA5951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939222-2559-389D-4810-2B9A1C087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93192-163F-17CE-18BA-52C072135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D0BABF-CEC5-C499-7BFF-41E87F46B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669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059FC1-C04C-83C7-0184-7461A55F9C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34216F-7687-635E-D32D-A21419D0F5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BF20F7-4F77-7AFC-8510-7D5760BFE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1F9178-437E-429F-8D73-28A0AC74B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A507D9-96E8-692F-3EF4-58F80E433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3282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A26113-B639-EAD7-B069-D9BF9A2C6B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0E2FAB-E8E6-2FF5-AC05-92A92FAD45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B7F83-88C5-AA1E-88EE-FE9659DED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1CC8E8-61DD-4422-937F-E2E68CFBA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99FF4E-6229-A532-ED23-4EF9B074E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836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BFFB1F-DDD6-E851-76FC-1FED89C28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07608E-0E0E-0D47-5655-494F5E94F7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ACACB-69D9-DD80-9400-67F127E76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3B19CF-1C2B-A173-F494-DD79FC77A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15F31-30AF-FD0D-5D9F-D598755AD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559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DBB8B8-3678-21EC-B097-2E20F264A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AF6A61-E9EB-5147-5593-FE9CAF056B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2173D-B140-1707-1AF3-96068548A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345344-43F6-6AD8-3AB5-88CA7DD63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95F1A3-FBF5-75BF-E8BB-2BEA35D64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9921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59811A-E983-17A0-1D8E-501A78568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45B049-426A-48E9-ECA8-C27ADD3A8A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CB28D0-F8E4-CB9C-6969-B1B77F3C30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E4BC4F-CEC8-359D-AC47-700E3C65B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BD6C7F-8FF8-CAC8-C29A-A4BB0FF41D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7BDE79-56F5-0838-E03D-A4B8BC78E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7605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A8944C-B374-928F-A958-2C271A5950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59F4D6-DEE1-FB7C-8BCD-1858931B8D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FE5CF7-6B63-7D90-5EAD-1806A51975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8F9D78-1768-21D7-9C3C-14069603B0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C7C858-DD8D-4A61-016D-A2773B699A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1C74F9-5692-E39E-1B92-E7CDF307F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68ECC1-7EAD-E622-057F-5FB4BAEC4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2670A2-1CC1-2454-54DB-09778FE7B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6494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F6480-1946-0590-1829-6E89469113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EF4A5A-CA7D-5A4A-2562-F196501E9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D1A029-A07D-5218-F161-31A2E3C9A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BDD14F-CE42-EE57-26E6-235B38E39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566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8B0D55D-A59B-6F4A-11D0-6D6BF2412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A381C0-07DE-FC80-ED38-3B809E1EC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CBD26D-5188-EAC6-25F5-226A42680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6351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9FFA56-784D-6734-9232-8ECAF02588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FD99C0-787D-2CD0-B4AD-94C8FE6D32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5D9627-6E61-BAB6-9804-B5C1C0E4D9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CDF5A6-6975-D57E-0FC3-9A9357A68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CF57AE-D268-8480-9FEB-01085BC74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273CAE-D8A6-8C0E-2E67-FAC7CC0DA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117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E2ADC-4200-1DBE-FC02-FD8823D61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44D2C3-0338-EB2F-0EEE-5CF76F0CAF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9DB2D9-C00C-CA64-66A0-0CC40989D5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F9064C-9232-8A50-DD78-BD5326E80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D14BBE-4007-87C4-A733-97B26A9E9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97A918-8C2C-FDA8-4DA7-D0B1A5127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615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3BEAB2-DEB8-971C-7231-0804304DA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B4C7CB-C88C-EEBF-8BAF-53A4488BF9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ACC581-2180-0A8F-DFBC-C5DEBE0507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5E648C1-35CD-406C-94D2-E2965272950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6487E3-AABA-A7D7-7C07-3A3EEE52E2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A6883C-2BB0-3357-DD68-725873F7BC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1594D0-6D37-47FD-8FF5-E0A3275974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004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blurry image of a dna test&#10;&#10;AI-generated content may be incorrect.">
            <a:extLst>
              <a:ext uri="{FF2B5EF4-FFF2-40B4-BE49-F238E27FC236}">
                <a16:creationId xmlns:a16="http://schemas.microsoft.com/office/drawing/2014/main" id="{DC8BE4E0-24C6-FD0D-74FC-FCB129E379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0402" y="533400"/>
            <a:ext cx="6578455" cy="5384152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2A0EDDB9-61A8-C336-4508-F137EC074FF9}"/>
              </a:ext>
            </a:extLst>
          </p:cNvPr>
          <p:cNvCxnSpPr>
            <a:cxnSpLocks/>
          </p:cNvCxnSpPr>
          <p:nvPr/>
        </p:nvCxnSpPr>
        <p:spPr>
          <a:xfrm>
            <a:off x="4375046" y="119746"/>
            <a:ext cx="53287" cy="6475228"/>
          </a:xfrm>
          <a:prstGeom prst="line">
            <a:avLst/>
          </a:prstGeom>
          <a:ln>
            <a:solidFill>
              <a:schemeClr val="bg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05B80079-E1F8-79FF-24BB-DA13740745C9}"/>
              </a:ext>
            </a:extLst>
          </p:cNvPr>
          <p:cNvSpPr/>
          <p:nvPr/>
        </p:nvSpPr>
        <p:spPr>
          <a:xfrm>
            <a:off x="2573080" y="685042"/>
            <a:ext cx="3882150" cy="4920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D8D35A-30AB-5A00-09CD-1CD2502E88D0}"/>
              </a:ext>
            </a:extLst>
          </p:cNvPr>
          <p:cNvSpPr txBox="1"/>
          <p:nvPr/>
        </p:nvSpPr>
        <p:spPr>
          <a:xfrm>
            <a:off x="2759446" y="445071"/>
            <a:ext cx="3357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1        2      3      4     5       6        7      8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D4FA97-2FD2-8889-CA8E-01FA3842D6B5}"/>
              </a:ext>
            </a:extLst>
          </p:cNvPr>
          <p:cNvSpPr txBox="1"/>
          <p:nvPr/>
        </p:nvSpPr>
        <p:spPr>
          <a:xfrm>
            <a:off x="2759446" y="5473789"/>
            <a:ext cx="3477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9      10   11    12     13   14     15    16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F0B974C-A265-90D0-E69B-A74B5F64EA85}"/>
              </a:ext>
            </a:extLst>
          </p:cNvPr>
          <p:cNvSpPr txBox="1"/>
          <p:nvPr/>
        </p:nvSpPr>
        <p:spPr>
          <a:xfrm>
            <a:off x="2583530" y="6139934"/>
            <a:ext cx="1618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ti-</a:t>
            </a:r>
            <a:r>
              <a:rPr lang="en-GB" dirty="0" err="1"/>
              <a:t>ADPr</a:t>
            </a:r>
            <a:r>
              <a:rPr lang="en-GB" dirty="0"/>
              <a:t>-blo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EC5B215-3335-C36E-1488-A06108D5336B}"/>
              </a:ext>
            </a:extLst>
          </p:cNvPr>
          <p:cNvSpPr txBox="1"/>
          <p:nvPr/>
        </p:nvSpPr>
        <p:spPr>
          <a:xfrm>
            <a:off x="4557729" y="6141850"/>
            <a:ext cx="1893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ti-dsDNA-blo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79F6F0-FEC9-D80B-E1C7-963117EF0389}"/>
              </a:ext>
            </a:extLst>
          </p:cNvPr>
          <p:cNvSpPr txBox="1"/>
          <p:nvPr/>
        </p:nvSpPr>
        <p:spPr>
          <a:xfrm>
            <a:off x="7922787" y="44141"/>
            <a:ext cx="28302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oth blots are developed together on the imager, the dotted line shows the jo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D7811EF-066F-32BB-D080-B953481930FA}"/>
              </a:ext>
            </a:extLst>
          </p:cNvPr>
          <p:cNvSpPr txBox="1"/>
          <p:nvPr/>
        </p:nvSpPr>
        <p:spPr>
          <a:xfrm>
            <a:off x="7915223" y="1123176"/>
            <a:ext cx="3982244" cy="5016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Anti </a:t>
            </a:r>
            <a:r>
              <a:rPr lang="en-GB" sz="1600" b="1" dirty="0" err="1"/>
              <a:t>ADPr</a:t>
            </a:r>
            <a:r>
              <a:rPr lang="en-GB" sz="1600" b="1" dirty="0"/>
              <a:t> blot</a:t>
            </a:r>
          </a:p>
          <a:p>
            <a:r>
              <a:rPr lang="en-GB" sz="1600" dirty="0"/>
              <a:t>1 1kb ladder</a:t>
            </a:r>
          </a:p>
          <a:p>
            <a:r>
              <a:rPr lang="en-GB" sz="1600" dirty="0"/>
              <a:t>2 Uncut gDNA (0ng/ml ATC 48h)</a:t>
            </a:r>
          </a:p>
          <a:p>
            <a:r>
              <a:rPr lang="en-GB" sz="1600" dirty="0"/>
              <a:t>3 </a:t>
            </a:r>
            <a:r>
              <a:rPr lang="en-GB" sz="1600" dirty="0" err="1"/>
              <a:t>mseI</a:t>
            </a:r>
            <a:r>
              <a:rPr lang="en-GB" sz="1600" dirty="0"/>
              <a:t> digested gDNA (0ng/ml ATC 48h)</a:t>
            </a:r>
          </a:p>
          <a:p>
            <a:r>
              <a:rPr lang="en-GB" sz="1600" dirty="0"/>
              <a:t>4 </a:t>
            </a:r>
            <a:r>
              <a:rPr lang="en-GB" sz="1600" dirty="0" err="1"/>
              <a:t>salI</a:t>
            </a:r>
            <a:r>
              <a:rPr lang="en-GB" sz="1600" dirty="0"/>
              <a:t> digested gDNA (0ng/ml ATC 48h)</a:t>
            </a:r>
          </a:p>
          <a:p>
            <a:r>
              <a:rPr lang="en-GB" sz="1600" b="1" dirty="0"/>
              <a:t>Anti dsDNA blot</a:t>
            </a:r>
          </a:p>
          <a:p>
            <a:r>
              <a:rPr lang="en-GB" sz="1600" dirty="0"/>
              <a:t>5 1kb ladder</a:t>
            </a:r>
          </a:p>
          <a:p>
            <a:r>
              <a:rPr lang="en-GB" sz="1600" dirty="0"/>
              <a:t>6 Uncut gDNA (0ng/ml ATC 48h)</a:t>
            </a:r>
          </a:p>
          <a:p>
            <a:r>
              <a:rPr lang="en-GB" sz="1600" dirty="0"/>
              <a:t>7 </a:t>
            </a:r>
            <a:r>
              <a:rPr lang="en-GB" sz="1600" dirty="0" err="1"/>
              <a:t>mseI</a:t>
            </a:r>
            <a:r>
              <a:rPr lang="en-GB" sz="1600" dirty="0"/>
              <a:t> digested gDNA (0ng/ml ATC 48h)</a:t>
            </a:r>
          </a:p>
          <a:p>
            <a:r>
              <a:rPr lang="en-GB" sz="1600" dirty="0"/>
              <a:t>8 </a:t>
            </a:r>
            <a:r>
              <a:rPr lang="en-GB" sz="1600" dirty="0" err="1"/>
              <a:t>salI</a:t>
            </a:r>
            <a:r>
              <a:rPr lang="en-GB" sz="1600" dirty="0"/>
              <a:t> digested gDNA (0ng/ml ATC 48h</a:t>
            </a:r>
          </a:p>
          <a:p>
            <a:r>
              <a:rPr lang="en-GB" sz="1600" b="1" dirty="0"/>
              <a:t>Anti </a:t>
            </a:r>
            <a:r>
              <a:rPr lang="en-GB" sz="1600" b="1" dirty="0" err="1"/>
              <a:t>ADPr</a:t>
            </a:r>
            <a:r>
              <a:rPr lang="en-GB" sz="1600" b="1" dirty="0"/>
              <a:t> blot</a:t>
            </a:r>
            <a:endParaRPr lang="en-GB" sz="1600" dirty="0"/>
          </a:p>
          <a:p>
            <a:r>
              <a:rPr lang="en-GB" sz="1600" dirty="0"/>
              <a:t>9 1kb ladder</a:t>
            </a:r>
          </a:p>
          <a:p>
            <a:r>
              <a:rPr lang="en-GB" sz="1600" dirty="0"/>
              <a:t>10 Uncut gDNA (200ng/ml ATC 48h)</a:t>
            </a:r>
          </a:p>
          <a:p>
            <a:r>
              <a:rPr lang="en-GB" sz="1600" dirty="0"/>
              <a:t>11 </a:t>
            </a:r>
            <a:r>
              <a:rPr lang="en-GB" sz="1600" dirty="0" err="1"/>
              <a:t>mseI</a:t>
            </a:r>
            <a:r>
              <a:rPr lang="en-GB" sz="1600" dirty="0"/>
              <a:t> digested gDNA (200ng/ml ATC 48h)</a:t>
            </a:r>
          </a:p>
          <a:p>
            <a:r>
              <a:rPr lang="en-GB" sz="1600" dirty="0"/>
              <a:t>12 </a:t>
            </a:r>
            <a:r>
              <a:rPr lang="en-GB" sz="1600" dirty="0" err="1"/>
              <a:t>salI</a:t>
            </a:r>
            <a:r>
              <a:rPr lang="en-GB" sz="1600" dirty="0"/>
              <a:t> digested gDNA (200ng/ml ATC 48h</a:t>
            </a:r>
          </a:p>
          <a:p>
            <a:r>
              <a:rPr lang="en-GB" sz="1600" b="1" dirty="0"/>
              <a:t>Anti dsDNA blot</a:t>
            </a:r>
          </a:p>
          <a:p>
            <a:r>
              <a:rPr lang="en-GB" sz="1600" dirty="0"/>
              <a:t>13 1kb ladder</a:t>
            </a:r>
          </a:p>
          <a:p>
            <a:r>
              <a:rPr lang="en-GB" sz="1600" dirty="0"/>
              <a:t>14 Uncut gDNA (200ng/ml ATC 48h)</a:t>
            </a:r>
          </a:p>
          <a:p>
            <a:r>
              <a:rPr lang="en-GB" sz="1600" dirty="0"/>
              <a:t>15 </a:t>
            </a:r>
            <a:r>
              <a:rPr lang="en-GB" sz="1600" dirty="0" err="1"/>
              <a:t>mseI</a:t>
            </a:r>
            <a:r>
              <a:rPr lang="en-GB" sz="1600" dirty="0"/>
              <a:t> digested gDNA (200ng/ml ATC 48h)</a:t>
            </a:r>
          </a:p>
          <a:p>
            <a:r>
              <a:rPr lang="en-GB" sz="1600" dirty="0"/>
              <a:t>16 </a:t>
            </a:r>
            <a:r>
              <a:rPr lang="en-GB" sz="1600" dirty="0" err="1"/>
              <a:t>salI</a:t>
            </a:r>
            <a:r>
              <a:rPr lang="en-GB" sz="1600" dirty="0"/>
              <a:t> digested gDNA (200ng/ml ATC 48h</a:t>
            </a:r>
          </a:p>
        </p:txBody>
      </p:sp>
    </p:spTree>
    <p:extLst>
      <p:ext uri="{BB962C8B-B14F-4D97-AF65-F5344CB8AC3E}">
        <p14:creationId xmlns:p14="http://schemas.microsoft.com/office/powerpoint/2010/main" val="1159611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98730C5DFCF246B154C9145A71693D" ma:contentTypeVersion="12" ma:contentTypeDescription="Create a new document." ma:contentTypeScope="" ma:versionID="ae7b9c86051f4e040dac568b69fb0128">
  <xsd:schema xmlns:xsd="http://www.w3.org/2001/XMLSchema" xmlns:xs="http://www.w3.org/2001/XMLSchema" xmlns:p="http://schemas.microsoft.com/office/2006/metadata/properties" xmlns:ns2="3d001f60-a2d7-4d7d-b13f-e8538330c949" xmlns:ns3="33967b2d-0c2e-4b90-8b20-39fe1832c3e1" targetNamespace="http://schemas.microsoft.com/office/2006/metadata/properties" ma:root="true" ma:fieldsID="757bba51fdd94759903aa6d2e9861751" ns2:_="" ns3:_="">
    <xsd:import namespace="3d001f60-a2d7-4d7d-b13f-e8538330c949"/>
    <xsd:import namespace="33967b2d-0c2e-4b90-8b20-39fe1832c3e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001f60-a2d7-4d7d-b13f-e8538330c9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58692e38-9dd4-4db7-af25-16fcd4767bb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3967b2d-0c2e-4b90-8b20-39fe1832c3e1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5c77dd19-a496-43b3-950e-f870f8ef18e7}" ma:internalName="TaxCatchAll" ma:showField="CatchAllData" ma:web="33967b2d-0c2e-4b90-8b20-39fe1832c3e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d001f60-a2d7-4d7d-b13f-e8538330c949">
      <Terms xmlns="http://schemas.microsoft.com/office/infopath/2007/PartnerControls"/>
    </lcf76f155ced4ddcb4097134ff3c332f>
    <TaxCatchAll xmlns="33967b2d-0c2e-4b90-8b20-39fe1832c3e1" xsi:nil="true"/>
  </documentManagement>
</p:properties>
</file>

<file path=customXml/itemProps1.xml><?xml version="1.0" encoding="utf-8"?>
<ds:datastoreItem xmlns:ds="http://schemas.openxmlformats.org/officeDocument/2006/customXml" ds:itemID="{5C8E2F94-8C4B-4623-8770-52036B528DEB}"/>
</file>

<file path=customXml/itemProps2.xml><?xml version="1.0" encoding="utf-8"?>
<ds:datastoreItem xmlns:ds="http://schemas.openxmlformats.org/officeDocument/2006/customXml" ds:itemID="{12DD359C-A2B9-4B76-9F5C-38DF6B799741}"/>
</file>

<file path=customXml/itemProps3.xml><?xml version="1.0" encoding="utf-8"?>
<ds:datastoreItem xmlns:ds="http://schemas.openxmlformats.org/officeDocument/2006/customXml" ds:itemID="{8D446508-F862-4FFD-8CCA-2898D98E0F87}"/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82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tler, Rachel Dr (Sch of Biosciences)</dc:creator>
  <cp:lastModifiedBy>Butler, Rachel Dr (Sch of Biosciences)</cp:lastModifiedBy>
  <cp:revision>1</cp:revision>
  <dcterms:created xsi:type="dcterms:W3CDTF">2025-03-12T11:50:34Z</dcterms:created>
  <dcterms:modified xsi:type="dcterms:W3CDTF">2025-03-12T11:58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98730C5DFCF246B154C9145A71693D</vt:lpwstr>
  </property>
</Properties>
</file>